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48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319">
          <p15:clr>
            <a:srgbClr val="A4A3A4"/>
          </p15:clr>
        </p15:guide>
        <p15:guide id="2" pos="5759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7F7F7F"/>
    <a:srgbClr val="FFF799"/>
    <a:srgbClr val="FC633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howGuides="1">
      <p:cViewPr varScale="1">
        <p:scale>
          <a:sx n="118" d="100"/>
          <a:sy n="118" d="100"/>
        </p:scale>
        <p:origin x="1738" y="86"/>
      </p:cViewPr>
      <p:guideLst>
        <p:guide orient="horz" pos="4319"/>
        <p:guide pos="575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4F17D82-3F1F-41A1-912B-03A6EB64A52A}" type="datetimeFigureOut">
              <a:rPr lang="en-US" smtClean="0"/>
              <a:t>3/6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7639AA6-3582-4AB6-98DA-ECA16C4C0E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899563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F2347-CE0C-4583-80BB-574B082C2EA4}" type="datetimeFigureOut">
              <a:rPr lang="en-US" smtClean="0"/>
              <a:pPr/>
              <a:t>3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E7F135-3A18-476A-82D6-1699F5E94BA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07626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F2347-CE0C-4583-80BB-574B082C2EA4}" type="datetimeFigureOut">
              <a:rPr lang="en-US" smtClean="0"/>
              <a:pPr/>
              <a:t>3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E7F135-3A18-476A-82D6-1699F5E94BA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3205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F2347-CE0C-4583-80BB-574B082C2EA4}" type="datetimeFigureOut">
              <a:rPr lang="en-US" smtClean="0"/>
              <a:pPr/>
              <a:t>3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E7F135-3A18-476A-82D6-1699F5E94BA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51094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F2347-CE0C-4583-80BB-574B082C2EA4}" type="datetimeFigureOut">
              <a:rPr lang="en-US" smtClean="0"/>
              <a:pPr/>
              <a:t>3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E7F135-3A18-476A-82D6-1699F5E94BA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82472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F2347-CE0C-4583-80BB-574B082C2EA4}" type="datetimeFigureOut">
              <a:rPr lang="en-US" smtClean="0"/>
              <a:pPr/>
              <a:t>3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E7F135-3A18-476A-82D6-1699F5E94BA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27638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F2347-CE0C-4583-80BB-574B082C2EA4}" type="datetimeFigureOut">
              <a:rPr lang="en-US" smtClean="0"/>
              <a:pPr/>
              <a:t>3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E7F135-3A18-476A-82D6-1699F5E94BA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78370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F2347-CE0C-4583-80BB-574B082C2EA4}" type="datetimeFigureOut">
              <a:rPr lang="en-US" smtClean="0"/>
              <a:pPr/>
              <a:t>3/6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E7F135-3A18-476A-82D6-1699F5E94BA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59113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F2347-CE0C-4583-80BB-574B082C2EA4}" type="datetimeFigureOut">
              <a:rPr lang="en-US" smtClean="0"/>
              <a:pPr/>
              <a:t>3/6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E7F135-3A18-476A-82D6-1699F5E94BA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07111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F2347-CE0C-4583-80BB-574B082C2EA4}" type="datetimeFigureOut">
              <a:rPr lang="en-US" smtClean="0"/>
              <a:pPr/>
              <a:t>3/6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E7F135-3A18-476A-82D6-1699F5E94BA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08992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F2347-CE0C-4583-80BB-574B082C2EA4}" type="datetimeFigureOut">
              <a:rPr lang="en-US" smtClean="0"/>
              <a:pPr/>
              <a:t>3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E7F135-3A18-476A-82D6-1699F5E94BA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03708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F2347-CE0C-4583-80BB-574B082C2EA4}" type="datetimeFigureOut">
              <a:rPr lang="en-US" smtClean="0"/>
              <a:pPr/>
              <a:t>3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E7F135-3A18-476A-82D6-1699F5E94BA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57621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BF2347-CE0C-4583-80BB-574B082C2EA4}" type="datetimeFigureOut">
              <a:rPr lang="en-US" smtClean="0"/>
              <a:pPr/>
              <a:t>3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E7F135-3A18-476A-82D6-1699F5E94BA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85129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l="3479"/>
          <a:stretch/>
        </p:blipFill>
        <p:spPr>
          <a:xfrm>
            <a:off x="546100" y="1905000"/>
            <a:ext cx="8458200" cy="2219185"/>
          </a:xfrm>
          <a:prstGeom prst="rect">
            <a:avLst/>
          </a:prstGeom>
        </p:spPr>
      </p:pic>
      <p:grpSp>
        <p:nvGrpSpPr>
          <p:cNvPr id="5" name="Group 4"/>
          <p:cNvGrpSpPr/>
          <p:nvPr/>
        </p:nvGrpSpPr>
        <p:grpSpPr>
          <a:xfrm>
            <a:off x="174464" y="1879151"/>
            <a:ext cx="486030" cy="543404"/>
            <a:chOff x="174464" y="1879151"/>
            <a:chExt cx="486030" cy="543404"/>
          </a:xfrm>
        </p:grpSpPr>
        <p:sp>
          <p:nvSpPr>
            <p:cNvPr id="9" name="TextBox 8"/>
            <p:cNvSpPr txBox="1"/>
            <p:nvPr/>
          </p:nvSpPr>
          <p:spPr>
            <a:xfrm>
              <a:off x="174464" y="1879151"/>
              <a:ext cx="48603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/>
                <a:t>NbFDH1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174464" y="1993601"/>
              <a:ext cx="47000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/>
                <a:t>NtFDH1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174464" y="2108051"/>
              <a:ext cx="4443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/>
                <a:t>SlFDH1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174464" y="2222500"/>
              <a:ext cx="46358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/>
                <a:t>AtFDH1</a:t>
              </a:r>
            </a:p>
          </p:txBody>
        </p:sp>
      </p:grpSp>
      <p:grpSp>
        <p:nvGrpSpPr>
          <p:cNvPr id="25" name="Group 24"/>
          <p:cNvGrpSpPr/>
          <p:nvPr/>
        </p:nvGrpSpPr>
        <p:grpSpPr>
          <a:xfrm>
            <a:off x="174464" y="2457450"/>
            <a:ext cx="486030" cy="549754"/>
            <a:chOff x="174464" y="1879151"/>
            <a:chExt cx="486030" cy="549754"/>
          </a:xfrm>
        </p:grpSpPr>
        <p:sp>
          <p:nvSpPr>
            <p:cNvPr id="26" name="TextBox 25"/>
            <p:cNvSpPr txBox="1"/>
            <p:nvPr/>
          </p:nvSpPr>
          <p:spPr>
            <a:xfrm>
              <a:off x="174464" y="1879151"/>
              <a:ext cx="48603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/>
                <a:t>NbFDH1</a:t>
              </a: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174464" y="1993601"/>
              <a:ext cx="47000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/>
                <a:t>NtFDH1</a:t>
              </a: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174464" y="2114401"/>
              <a:ext cx="4443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/>
                <a:t>SlFDH1</a:t>
              </a: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174464" y="2228850"/>
              <a:ext cx="46358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/>
                <a:t>AtFDH1</a:t>
              </a:r>
            </a:p>
          </p:txBody>
        </p:sp>
      </p:grpSp>
      <p:grpSp>
        <p:nvGrpSpPr>
          <p:cNvPr id="30" name="Group 29"/>
          <p:cNvGrpSpPr/>
          <p:nvPr/>
        </p:nvGrpSpPr>
        <p:grpSpPr>
          <a:xfrm>
            <a:off x="174464" y="3031646"/>
            <a:ext cx="486030" cy="543404"/>
            <a:chOff x="174464" y="1879151"/>
            <a:chExt cx="486030" cy="543404"/>
          </a:xfrm>
        </p:grpSpPr>
        <p:sp>
          <p:nvSpPr>
            <p:cNvPr id="31" name="TextBox 30"/>
            <p:cNvSpPr txBox="1"/>
            <p:nvPr/>
          </p:nvSpPr>
          <p:spPr>
            <a:xfrm>
              <a:off x="174464" y="1879151"/>
              <a:ext cx="48603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/>
                <a:t>NbFDH1</a:t>
              </a: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174464" y="1999951"/>
              <a:ext cx="47000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/>
                <a:t>NtFDH1</a:t>
              </a: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174464" y="2108051"/>
              <a:ext cx="4443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/>
                <a:t>SlFDH1</a:t>
              </a: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174464" y="2222500"/>
              <a:ext cx="46358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/>
                <a:t>AtFDH1</a:t>
              </a:r>
            </a:p>
          </p:txBody>
        </p:sp>
      </p:grpSp>
      <p:grpSp>
        <p:nvGrpSpPr>
          <p:cNvPr id="35" name="Group 34"/>
          <p:cNvGrpSpPr/>
          <p:nvPr/>
        </p:nvGrpSpPr>
        <p:grpSpPr>
          <a:xfrm>
            <a:off x="174464" y="3613150"/>
            <a:ext cx="486030" cy="549754"/>
            <a:chOff x="174464" y="1879151"/>
            <a:chExt cx="486030" cy="549754"/>
          </a:xfrm>
        </p:grpSpPr>
        <p:sp>
          <p:nvSpPr>
            <p:cNvPr id="36" name="TextBox 35"/>
            <p:cNvSpPr txBox="1"/>
            <p:nvPr/>
          </p:nvSpPr>
          <p:spPr>
            <a:xfrm>
              <a:off x="174464" y="1879151"/>
              <a:ext cx="48603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/>
                <a:t>NbFDH1</a:t>
              </a: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174464" y="1993601"/>
              <a:ext cx="47000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/>
                <a:t>NtFDH1</a:t>
              </a: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174464" y="2114401"/>
              <a:ext cx="4443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/>
                <a:t>SlFDH1</a:t>
              </a: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174464" y="2228850"/>
              <a:ext cx="46358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/>
                <a:t>AtFDH1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0126330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730</TotalTime>
  <Words>16</Words>
  <Application>Microsoft Office PowerPoint</Application>
  <PresentationFormat>On-screen Show (4:3)</PresentationFormat>
  <Paragraphs>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Noble Foundati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mrojas</dc:creator>
  <cp:lastModifiedBy>Lee,Seonghee</cp:lastModifiedBy>
  <cp:revision>134</cp:revision>
  <dcterms:created xsi:type="dcterms:W3CDTF">2012-05-31T18:29:42Z</dcterms:created>
  <dcterms:modified xsi:type="dcterms:W3CDTF">2022-03-06T21:47:14Z</dcterms:modified>
</cp:coreProperties>
</file>